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18.jpeg" ContentType="image/jpeg"/>
  <Override PartName="/ppt/media/image7.jpeg" ContentType="image/jpeg"/>
  <Override PartName="/ppt/media/image28.jpeg" ContentType="image/jpeg"/>
  <Override PartName="/ppt/media/image12.jpeg" ContentType="image/jpeg"/>
  <Override PartName="/ppt/media/image10.jpeg" ContentType="image/jpeg"/>
  <Override PartName="/ppt/media/image29.jpeg" ContentType="image/jpeg"/>
  <Override PartName="/ppt/media/image8.jpeg" ContentType="image/jpeg"/>
  <Override PartName="/ppt/media/image6.jpeg" ContentType="image/jpeg"/>
  <Override PartName="/ppt/media/image27.jpeg" ContentType="image/jpeg"/>
  <Override PartName="/ppt/media/image11.jpeg" ContentType="image/jpeg"/>
  <Override PartName="/ppt/media/image9.jpeg" ContentType="image/jpeg"/>
  <Override PartName="/ppt/media/image30.jpeg" ContentType="image/jpeg"/>
  <Override PartName="/ppt/media/image3.jpeg" ContentType="image/jpeg"/>
  <Override PartName="/ppt/media/image24.jpeg" ContentType="image/jpeg"/>
  <Override PartName="/ppt/media/image31.png" ContentType="image/png"/>
  <Override PartName="/ppt/media/image13.jpeg" ContentType="image/jpeg"/>
  <Override PartName="/ppt/media/image33.png" ContentType="image/png"/>
  <Override PartName="/ppt/media/image14.jpeg" ContentType="image/jpeg"/>
  <Override PartName="/ppt/media/image5.jpeg" ContentType="image/jpeg"/>
  <Override PartName="/ppt/media/image26.jpeg" ContentType="image/jpeg"/>
  <Override PartName="/ppt/media/image4.jpeg" ContentType="image/jpeg"/>
  <Override PartName="/ppt/media/image25.jpeg" ContentType="image/jpeg"/>
  <Override PartName="/ppt/media/image32.png" ContentType="image/png"/>
  <Override PartName="/ppt/media/image1.jpeg" ContentType="image/jpeg"/>
  <Override PartName="/ppt/media/image22.jpeg" ContentType="image/jpeg"/>
  <Override PartName="/ppt/media/image2.jpeg" ContentType="image/jpeg"/>
  <Override PartName="/ppt/media/image23.jpeg" ContentType="image/jpeg"/>
  <Override PartName="/ppt/media/image15.jpeg" ContentType="image/jpeg"/>
  <Override PartName="/ppt/media/image16.jpeg" ContentType="image/jpeg"/>
  <Override PartName="/ppt/media/image17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51675" cy="90789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9AECB-66D6-4D8A-9849-4511E7BF66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D1E13-53BC-4169-9285-EBB5CAF754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A72E3-BE2E-46B5-B10D-877CF13E96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E476F-493D-4E1E-B25E-AFD1166171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6DACD-CD5A-452D-9DF9-5D92886DDD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6B21B-914C-4E0F-827B-031A78FA71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F2033-47E0-40C2-8BF6-E8A5E43C1E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AB10D-0A18-4F16-8A20-E215210C71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C29F6-EDE4-478D-B977-6927DB2527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570A9-2E1D-4A2E-AB5D-D320AEA25A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D196E-0D8B-485A-9BBE-E8C12AAC2D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23692-4DDA-48CE-80FD-68892D7605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FF717F-8679-4E07-A089-E95106D9F64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image" Target="../media/image29.jpeg"/><Relationship Id="rId30" Type="http://schemas.openxmlformats.org/officeDocument/2006/relationships/image" Target="../media/image30.jpe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7"/>
          <p:cNvSpPr/>
          <p:nvPr/>
        </p:nvSpPr>
        <p:spPr>
          <a:xfrm>
            <a:off x="216000" y="152280"/>
            <a:ext cx="77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77"/>
          <p:cNvGrpSpPr/>
          <p:nvPr/>
        </p:nvGrpSpPr>
        <p:grpSpPr>
          <a:xfrm>
            <a:off x="52560" y="496800"/>
            <a:ext cx="8977320" cy="2998800"/>
            <a:chOff x="52560" y="496800"/>
            <a:chExt cx="8977320" cy="2998800"/>
          </a:xfrm>
        </p:grpSpPr>
        <p:sp>
          <p:nvSpPr>
            <p:cNvPr id="43" name="TextBox 6"/>
            <p:cNvSpPr/>
            <p:nvPr/>
          </p:nvSpPr>
          <p:spPr>
            <a:xfrm>
              <a:off x="71280" y="1214640"/>
              <a:ext cx="68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C-3 R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15"/>
            <p:cNvSpPr/>
            <p:nvPr/>
          </p:nvSpPr>
          <p:spPr>
            <a:xfrm>
              <a:off x="52920" y="2108520"/>
              <a:ext cx="83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U145R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5" name="Picture 29" descr="12.jpg"/>
            <p:cNvPicPr/>
            <p:nvPr/>
          </p:nvPicPr>
          <p:blipFill>
            <a:blip r:embed="rId1"/>
            <a:stretch/>
          </p:blipFill>
          <p:spPr>
            <a:xfrm>
              <a:off x="744120" y="9694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" name="Picture 2" descr="d:\Documents and Settings\yongl\Desktop\Nancy\RT result\colone\colony image\2\1.jpg"/>
            <p:cNvPicPr/>
            <p:nvPr/>
          </p:nvPicPr>
          <p:blipFill>
            <a:blip r:embed="rId2"/>
            <a:stretch/>
          </p:blipFill>
          <p:spPr>
            <a:xfrm>
              <a:off x="745920" y="183060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7" name="Picture 14" descr="d:\Documents and Settings\yongl\Desktop\Nancy\RT result\colone\colony image\2\30.jpg"/>
            <p:cNvPicPr/>
            <p:nvPr/>
          </p:nvPicPr>
          <p:blipFill>
            <a:blip r:embed="rId3"/>
            <a:stretch/>
          </p:blipFill>
          <p:spPr>
            <a:xfrm>
              <a:off x="742320" y="26931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8" name="Picture 22" descr="5.jpg"/>
            <p:cNvPicPr/>
            <p:nvPr/>
          </p:nvPicPr>
          <p:blipFill>
            <a:blip r:embed="rId4"/>
            <a:stretch/>
          </p:blipFill>
          <p:spPr>
            <a:xfrm>
              <a:off x="1576080" y="269532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9" name="Picture 2" descr="6.jpg"/>
            <p:cNvPicPr/>
            <p:nvPr/>
          </p:nvPicPr>
          <p:blipFill>
            <a:blip r:embed="rId5"/>
            <a:stretch/>
          </p:blipFill>
          <p:spPr>
            <a:xfrm>
              <a:off x="1576080" y="18381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0" name="Picture 4" descr="d:\Documents and Settings\yongl\Desktop\Nancy\RT result\colone\colony image\3\DSC01835-1.jpg"/>
            <p:cNvPicPr/>
            <p:nvPr/>
          </p:nvPicPr>
          <p:blipFill>
            <a:blip r:embed="rId6"/>
            <a:stretch/>
          </p:blipFill>
          <p:spPr>
            <a:xfrm>
              <a:off x="2398320" y="18356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1" name="TextBox 14"/>
            <p:cNvSpPr/>
            <p:nvPr/>
          </p:nvSpPr>
          <p:spPr>
            <a:xfrm>
              <a:off x="52560" y="2926080"/>
              <a:ext cx="847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NCaPR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21"/>
            <p:cNvSpPr/>
            <p:nvPr/>
          </p:nvSpPr>
          <p:spPr>
            <a:xfrm>
              <a:off x="1644120" y="667440"/>
              <a:ext cx="685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 Gy R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22"/>
            <p:cNvSpPr/>
            <p:nvPr/>
          </p:nvSpPr>
          <p:spPr>
            <a:xfrm>
              <a:off x="2421000" y="667440"/>
              <a:ext cx="70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EZ23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3"/>
            <p:cNvSpPr/>
            <p:nvPr/>
          </p:nvSpPr>
          <p:spPr>
            <a:xfrm>
              <a:off x="5684760" y="521640"/>
              <a:ext cx="699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EZ235+6 Gy R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4"/>
            <p:cNvSpPr/>
            <p:nvPr/>
          </p:nvSpPr>
          <p:spPr>
            <a:xfrm>
              <a:off x="791640" y="667440"/>
              <a:ext cx="65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6" name="Picture 24" descr="d:\Documents and Settings\yongl\Desktop\Nancy\RT result\colone\colony image\4\DSC01852-m.jpg"/>
            <p:cNvPicPr/>
            <p:nvPr/>
          </p:nvPicPr>
          <p:blipFill>
            <a:blip r:embed="rId7"/>
            <a:stretch/>
          </p:blipFill>
          <p:spPr>
            <a:xfrm>
              <a:off x="2404080" y="270360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7" name="Picture 26" descr="d:\Documents and Settings\yongl\Desktop\Nancy\RT result\colone\colony image\4\DSC01849-m.jpg"/>
            <p:cNvPicPr/>
            <p:nvPr/>
          </p:nvPicPr>
          <p:blipFill>
            <a:blip r:embed="rId8"/>
            <a:stretch/>
          </p:blipFill>
          <p:spPr>
            <a:xfrm>
              <a:off x="2398320" y="9694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8" name="TextBox 23"/>
            <p:cNvSpPr/>
            <p:nvPr/>
          </p:nvSpPr>
          <p:spPr>
            <a:xfrm>
              <a:off x="3306960" y="66744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PI10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3"/>
            <p:cNvSpPr/>
            <p:nvPr/>
          </p:nvSpPr>
          <p:spPr>
            <a:xfrm>
              <a:off x="4833720" y="650520"/>
              <a:ext cx="840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Rapamy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0" name="Picture 9" descr="D:\2012-2013 Nancy\RR EXPERIMENT\COLONY ASSAY\colone\3inhibitor RR colony\modify\DSC01863-m.jpg"/>
            <p:cNvPicPr/>
            <p:nvPr/>
          </p:nvPicPr>
          <p:blipFill>
            <a:blip r:embed="rId9"/>
            <a:stretch/>
          </p:blipFill>
          <p:spPr>
            <a:xfrm>
              <a:off x="8223120" y="26924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1" name="Picture 22" descr="d:\Documents and Settings\yongl\Desktop\Nancy\RT result\colone\colony image\4\DSC01854-m.jpg"/>
            <p:cNvPicPr/>
            <p:nvPr/>
          </p:nvPicPr>
          <p:blipFill>
            <a:blip r:embed="rId10"/>
            <a:stretch/>
          </p:blipFill>
          <p:spPr>
            <a:xfrm>
              <a:off x="6525000" y="18363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2" name="Picture 29" descr="d:\Documents and Settings\yongl\Desktop\Nancy\RT result\colone\colony image\4\DSC01855-m.jpg"/>
            <p:cNvPicPr/>
            <p:nvPr/>
          </p:nvPicPr>
          <p:blipFill>
            <a:blip r:embed="rId11"/>
            <a:stretch/>
          </p:blipFill>
          <p:spPr>
            <a:xfrm>
              <a:off x="6550560" y="268740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3" name="Picture 8" descr="D:\2012-2013 Nancy\RR EXPERIMENT\COLONY ASSAY\colone\3inhibitor RR colony\modify\DSC01876-m.jpg"/>
            <p:cNvPicPr/>
            <p:nvPr/>
          </p:nvPicPr>
          <p:blipFill>
            <a:blip r:embed="rId12"/>
            <a:stretch/>
          </p:blipFill>
          <p:spPr>
            <a:xfrm>
              <a:off x="6507720" y="96732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4" name="TextBox 23"/>
            <p:cNvSpPr/>
            <p:nvPr/>
          </p:nvSpPr>
          <p:spPr>
            <a:xfrm>
              <a:off x="4083480" y="667440"/>
              <a:ext cx="69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BKM1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7" descr="D:\2012-2013 Nancy\RR EXPERIMENT\COLONY ASSAY\colone\3inhibitor RR colony\modify\DSC01874-m.jpg"/>
            <p:cNvPicPr/>
            <p:nvPr/>
          </p:nvPicPr>
          <p:blipFill>
            <a:blip r:embed="rId13"/>
            <a:stretch/>
          </p:blipFill>
          <p:spPr>
            <a:xfrm>
              <a:off x="8175240" y="96192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6" name="Picture 9" descr="D:\2012-2013 Nancy\RR EXPERIMENT\COLONY ASSAY\colone\3inhibitor RR colony\modify\DSC01697-m.jpg"/>
            <p:cNvPicPr/>
            <p:nvPr/>
          </p:nvPicPr>
          <p:blipFill>
            <a:blip r:embed="rId14"/>
            <a:stretch/>
          </p:blipFill>
          <p:spPr>
            <a:xfrm>
              <a:off x="8206920" y="18316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7" name="TextBox 23"/>
            <p:cNvSpPr/>
            <p:nvPr/>
          </p:nvSpPr>
          <p:spPr>
            <a:xfrm>
              <a:off x="6489360" y="507240"/>
              <a:ext cx="727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PI10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+6 Gy R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3"/>
            <p:cNvSpPr/>
            <p:nvPr/>
          </p:nvSpPr>
          <p:spPr>
            <a:xfrm>
              <a:off x="8150040" y="496800"/>
              <a:ext cx="879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Rapamyc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+6 Gy R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23"/>
            <p:cNvSpPr/>
            <p:nvPr/>
          </p:nvSpPr>
          <p:spPr>
            <a:xfrm>
              <a:off x="7327800" y="496800"/>
              <a:ext cx="7916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BKM1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+6 Gy R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" name="Picture 8" descr="D:\2012-2013 Nancy\RR EXPERIMENT\COLONY ASSAY\colone\3inhibitor RR colony\modify\DSC01875-m.jpg"/>
            <p:cNvPicPr/>
            <p:nvPr/>
          </p:nvPicPr>
          <p:blipFill>
            <a:blip r:embed="rId15"/>
            <a:stretch/>
          </p:blipFill>
          <p:spPr>
            <a:xfrm>
              <a:off x="5697000" y="18363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1" name="Picture 5" descr="D:\2012-2013 Nancy\RR EXPERIMENT\COLONY ASSAY\colone\3inhibitor RR colony\modify\DSC01872-m.jpg"/>
            <p:cNvPicPr/>
            <p:nvPr/>
          </p:nvPicPr>
          <p:blipFill>
            <a:blip r:embed="rId16"/>
            <a:stretch/>
          </p:blipFill>
          <p:spPr>
            <a:xfrm>
              <a:off x="5681880" y="9680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2" name="Picture 11" descr="D:\2012-2013 Nancy\RR EXPERIMENT\COLONY ASSAY\colone\3inhibitor RR colony\modify\DSC01868-m.jpg"/>
            <p:cNvPicPr/>
            <p:nvPr/>
          </p:nvPicPr>
          <p:blipFill>
            <a:blip r:embed="rId17"/>
            <a:stretch/>
          </p:blipFill>
          <p:spPr>
            <a:xfrm>
              <a:off x="5715720" y="26931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3" name="Picture 3" descr="D:\2012-2013-2014 Nancy\RR EXPERIMENT\COLONY ASSAY\0813\IMG_1530-m.jpg"/>
            <p:cNvPicPr/>
            <p:nvPr/>
          </p:nvPicPr>
          <p:blipFill>
            <a:blip r:embed="rId18"/>
            <a:srcRect l="6614" t="5489" r="6890" b="0"/>
            <a:stretch/>
          </p:blipFill>
          <p:spPr>
            <a:xfrm>
              <a:off x="3239640" y="26931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4" name="Picture 4" descr="D:\2012-2013-2014 Nancy\RR EXPERIMENT\COLONY ASSAY\0813\IMG_1534-m.jpg"/>
            <p:cNvPicPr/>
            <p:nvPr/>
          </p:nvPicPr>
          <p:blipFill>
            <a:blip r:embed="rId19"/>
            <a:stretch/>
          </p:blipFill>
          <p:spPr>
            <a:xfrm>
              <a:off x="4894560" y="26852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5" name="Picture 5" descr="D:\2012-2013-2014 Nancy\RR EXPERIMENT\COLONY ASSAY\0813\IMG_1537-m.jpg"/>
            <p:cNvPicPr/>
            <p:nvPr/>
          </p:nvPicPr>
          <p:blipFill>
            <a:blip r:embed="rId20"/>
            <a:stretch/>
          </p:blipFill>
          <p:spPr>
            <a:xfrm>
              <a:off x="4061880" y="26866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6" name="Picture 6" descr="D:\2012-2013-2014 Nancy\RR EXPERIMENT\COLONY ASSAY\0813\IMG_1538-m.jpg"/>
            <p:cNvPicPr/>
            <p:nvPr/>
          </p:nvPicPr>
          <p:blipFill>
            <a:blip r:embed="rId21"/>
            <a:stretch/>
          </p:blipFill>
          <p:spPr>
            <a:xfrm>
              <a:off x="4871880" y="18363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7" name="Picture 7" descr="D:\2012-2013-2014 Nancy\RR EXPERIMENT\COLONY ASSAY\0813\IMG_1545-m.jpg"/>
            <p:cNvPicPr/>
            <p:nvPr/>
          </p:nvPicPr>
          <p:blipFill>
            <a:blip r:embed="rId22"/>
            <a:stretch/>
          </p:blipFill>
          <p:spPr>
            <a:xfrm>
              <a:off x="1576080" y="9694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8" name="Picture 8" descr="D:\2012-2013-2014 Nancy\RR EXPERIMENT\COLONY ASSAY\0813\IMG_1549-m.jpg"/>
            <p:cNvPicPr/>
            <p:nvPr/>
          </p:nvPicPr>
          <p:blipFill>
            <a:blip r:embed="rId23"/>
            <a:stretch/>
          </p:blipFill>
          <p:spPr>
            <a:xfrm>
              <a:off x="3220920" y="97272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9" name="Picture 9" descr="D:\2012-2013-2014 Nancy\RR EXPERIMENT\COLONY ASSAY\0813\IMG_1553-m.jpg"/>
            <p:cNvPicPr/>
            <p:nvPr/>
          </p:nvPicPr>
          <p:blipFill>
            <a:blip r:embed="rId24"/>
            <a:stretch/>
          </p:blipFill>
          <p:spPr>
            <a:xfrm>
              <a:off x="3220920" y="18356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0" name="Picture 10" descr="D:\2012-2013-2014 Nancy\RR EXPERIMENT\COLONY ASSAY\0813\IMG_1555-m.jpg"/>
            <p:cNvPicPr/>
            <p:nvPr/>
          </p:nvPicPr>
          <p:blipFill>
            <a:blip r:embed="rId25"/>
            <a:stretch/>
          </p:blipFill>
          <p:spPr>
            <a:xfrm>
              <a:off x="4047120" y="18352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1" name="Picture 11" descr="D:\2012-2013-2014 Nancy\RR EXPERIMENT\COLONY ASSAY\0813\IMG_1556-m.jpg"/>
            <p:cNvPicPr/>
            <p:nvPr/>
          </p:nvPicPr>
          <p:blipFill>
            <a:blip r:embed="rId26"/>
            <a:stretch/>
          </p:blipFill>
          <p:spPr>
            <a:xfrm>
              <a:off x="4041720" y="97272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2" name="Picture 13" descr="D:\2012-2013-2014 Nancy\RR EXPERIMENT\COLONY ASSAY\0813\IMG_1567-m.jpg"/>
            <p:cNvPicPr/>
            <p:nvPr/>
          </p:nvPicPr>
          <p:blipFill>
            <a:blip r:embed="rId27"/>
            <a:stretch/>
          </p:blipFill>
          <p:spPr>
            <a:xfrm>
              <a:off x="4864320" y="96768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3" name="Picture 15" descr="D:\2012-2013-2014 Nancy\RR EXPERIMENT\COLONY ASSAY\0813\IMG_1554-m.jpg"/>
            <p:cNvPicPr/>
            <p:nvPr/>
          </p:nvPicPr>
          <p:blipFill>
            <a:blip r:embed="rId28"/>
            <a:stretch/>
          </p:blipFill>
          <p:spPr>
            <a:xfrm>
              <a:off x="7383600" y="26852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4" name="Picture 16" descr="D:\2012-2013-2014 Nancy\RR EXPERIMENT\COLONY ASSAY\0813\IMG_1562-m.jpg"/>
            <p:cNvPicPr/>
            <p:nvPr/>
          </p:nvPicPr>
          <p:blipFill>
            <a:blip r:embed="rId29"/>
            <a:stretch/>
          </p:blipFill>
          <p:spPr>
            <a:xfrm>
              <a:off x="7360200" y="184104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5" name="Picture 17" descr="D:\2012-2013-2014 Nancy\RR EXPERIMENT\COLONY ASSAY\0813\IMG_1558-m.jpg"/>
            <p:cNvPicPr/>
            <p:nvPr/>
          </p:nvPicPr>
          <p:blipFill>
            <a:blip r:embed="rId30"/>
            <a:stretch/>
          </p:blipFill>
          <p:spPr>
            <a:xfrm>
              <a:off x="7341480" y="970560"/>
              <a:ext cx="791640" cy="79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pic>
        <p:nvPicPr>
          <p:cNvPr id="86" name="Picture 5" descr=""/>
          <p:cNvPicPr/>
          <p:nvPr/>
        </p:nvPicPr>
        <p:blipFill>
          <a:blip r:embed="rId31"/>
          <a:stretch/>
        </p:blipFill>
        <p:spPr>
          <a:xfrm>
            <a:off x="471600" y="3809880"/>
            <a:ext cx="2519280" cy="251964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6" descr=""/>
          <p:cNvPicPr/>
          <p:nvPr/>
        </p:nvPicPr>
        <p:blipFill>
          <a:blip r:embed="rId32"/>
          <a:stretch/>
        </p:blipFill>
        <p:spPr>
          <a:xfrm>
            <a:off x="3306600" y="3809880"/>
            <a:ext cx="2519640" cy="251964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7" descr=""/>
          <p:cNvPicPr/>
          <p:nvPr/>
        </p:nvPicPr>
        <p:blipFill>
          <a:blip r:embed="rId33"/>
          <a:stretch/>
        </p:blipFill>
        <p:spPr>
          <a:xfrm>
            <a:off x="6384960" y="3809880"/>
            <a:ext cx="2519280" cy="2519640"/>
          </a:xfrm>
          <a:prstGeom prst="rect">
            <a:avLst/>
          </a:prstGeom>
          <a:ln w="0">
            <a:noFill/>
          </a:ln>
        </p:spPr>
      </p:pic>
      <p:sp>
        <p:nvSpPr>
          <p:cNvPr id="89" name="TextBox 49"/>
          <p:cNvSpPr/>
          <p:nvPr/>
        </p:nvSpPr>
        <p:spPr>
          <a:xfrm>
            <a:off x="382680" y="6858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50"/>
          <p:cNvSpPr/>
          <p:nvPr/>
        </p:nvSpPr>
        <p:spPr>
          <a:xfrm>
            <a:off x="307080" y="3733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i Yong</dc:creator>
  <dc:description/>
  <dc:language>en-US</dc:language>
  <cp:lastModifiedBy>Yong</cp:lastModifiedBy>
  <cp:lastPrinted>2014-08-08T02:56:27Z</cp:lastPrinted>
  <dcterms:modified xsi:type="dcterms:W3CDTF">2014-08-24T04:59:56Z</dcterms:modified>
  <cp:revision>90</cp:revision>
  <dc:subject/>
  <dc:title>PowerPoint Presentation</dc:title>
</cp:coreProperties>
</file>